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2" autoAdjust="0"/>
    <p:restoredTop sz="94660"/>
  </p:normalViewPr>
  <p:slideViewPr>
    <p:cSldViewPr snapToGrid="0">
      <p:cViewPr varScale="1">
        <p:scale>
          <a:sx n="90" d="100"/>
          <a:sy n="90" d="100"/>
        </p:scale>
        <p:origin x="84" y="5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BD01E-6920-47DD-82E1-7C0EF3EBF0F9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56DBA-65C5-4A1C-B62E-0C7BA1B684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65921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BD01E-6920-47DD-82E1-7C0EF3EBF0F9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56DBA-65C5-4A1C-B62E-0C7BA1B684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04058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BD01E-6920-47DD-82E1-7C0EF3EBF0F9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56DBA-65C5-4A1C-B62E-0C7BA1B684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0702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BD01E-6920-47DD-82E1-7C0EF3EBF0F9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56DBA-65C5-4A1C-B62E-0C7BA1B684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78442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BD01E-6920-47DD-82E1-7C0EF3EBF0F9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56DBA-65C5-4A1C-B62E-0C7BA1B684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01138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BD01E-6920-47DD-82E1-7C0EF3EBF0F9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56DBA-65C5-4A1C-B62E-0C7BA1B684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21516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BD01E-6920-47DD-82E1-7C0EF3EBF0F9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56DBA-65C5-4A1C-B62E-0C7BA1B684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24277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BD01E-6920-47DD-82E1-7C0EF3EBF0F9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56DBA-65C5-4A1C-B62E-0C7BA1B684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9301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BD01E-6920-47DD-82E1-7C0EF3EBF0F9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56DBA-65C5-4A1C-B62E-0C7BA1B684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63538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BD01E-6920-47DD-82E1-7C0EF3EBF0F9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56DBA-65C5-4A1C-B62E-0C7BA1B684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43426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BD01E-6920-47DD-82E1-7C0EF3EBF0F9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56DBA-65C5-4A1C-B62E-0C7BA1B684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90244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FBD01E-6920-47DD-82E1-7C0EF3EBF0F9}" type="datetimeFigureOut">
              <a:rPr kumimoji="1" lang="ja-JP" altLang="en-US" smtClean="0"/>
              <a:t>2021/6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656DBA-65C5-4A1C-B62E-0C7BA1B684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31925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F75F7E2A-7D0B-42C6-B7C4-0F8440DDFD77}"/>
              </a:ext>
            </a:extLst>
          </p:cNvPr>
          <p:cNvSpPr/>
          <p:nvPr/>
        </p:nvSpPr>
        <p:spPr>
          <a:xfrm>
            <a:off x="233917" y="1464101"/>
            <a:ext cx="218833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 Data 2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474B3029-FD7B-4DE0-9A57-AB808FEF365E}"/>
              </a:ext>
            </a:extLst>
          </p:cNvPr>
          <p:cNvGrpSpPr/>
          <p:nvPr/>
        </p:nvGrpSpPr>
        <p:grpSpPr>
          <a:xfrm>
            <a:off x="1510899" y="2466754"/>
            <a:ext cx="3377709" cy="3501705"/>
            <a:chOff x="1991833" y="1616149"/>
            <a:chExt cx="3377709" cy="3501705"/>
          </a:xfrm>
        </p:grpSpPr>
        <p:grpSp>
          <p:nvGrpSpPr>
            <p:cNvPr id="7" name="グループ化 6">
              <a:extLst>
                <a:ext uri="{FF2B5EF4-FFF2-40B4-BE49-F238E27FC236}">
                  <a16:creationId xmlns:a16="http://schemas.microsoft.com/office/drawing/2014/main" id="{95536E7E-AF95-4F1B-9E64-162E6B99F2EB}"/>
                </a:ext>
              </a:extLst>
            </p:cNvPr>
            <p:cNvGrpSpPr/>
            <p:nvPr/>
          </p:nvGrpSpPr>
          <p:grpSpPr>
            <a:xfrm>
              <a:off x="1991833" y="1616149"/>
              <a:ext cx="3377709" cy="3501705"/>
              <a:chOff x="1991833" y="1616149"/>
              <a:chExt cx="3377709" cy="3501705"/>
            </a:xfrm>
          </p:grpSpPr>
          <p:pic>
            <p:nvPicPr>
              <p:cNvPr id="4" name="図 3">
                <a:extLst>
                  <a:ext uri="{FF2B5EF4-FFF2-40B4-BE49-F238E27FC236}">
                    <a16:creationId xmlns:a16="http://schemas.microsoft.com/office/drawing/2014/main" id="{2E701B70-3308-4FDE-B80B-E4B2B289255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991833" y="1740145"/>
                <a:ext cx="3377709" cy="3377709"/>
              </a:xfrm>
              <a:prstGeom prst="rect">
                <a:avLst/>
              </a:prstGeom>
            </p:spPr>
          </p:pic>
          <p:sp>
            <p:nvSpPr>
              <p:cNvPr id="6" name="正方形/長方形 5">
                <a:extLst>
                  <a:ext uri="{FF2B5EF4-FFF2-40B4-BE49-F238E27FC236}">
                    <a16:creationId xmlns:a16="http://schemas.microsoft.com/office/drawing/2014/main" id="{9DB902D7-030A-4334-B23E-C8EF0F2C0804}"/>
                  </a:ext>
                </a:extLst>
              </p:cNvPr>
              <p:cNvSpPr/>
              <p:nvPr/>
            </p:nvSpPr>
            <p:spPr>
              <a:xfrm>
                <a:off x="3076353" y="1616149"/>
                <a:ext cx="2048540" cy="58833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86F55376-1D0A-4A69-A18F-63D7C6C84AA7}"/>
                </a:ext>
              </a:extLst>
            </p:cNvPr>
            <p:cNvSpPr/>
            <p:nvPr/>
          </p:nvSpPr>
          <p:spPr>
            <a:xfrm>
              <a:off x="2431312" y="4628707"/>
              <a:ext cx="2211572" cy="41821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CE35AB5A-747C-43F3-B87A-AEA230CA776E}"/>
              </a:ext>
            </a:extLst>
          </p:cNvPr>
          <p:cNvSpPr/>
          <p:nvPr/>
        </p:nvSpPr>
        <p:spPr>
          <a:xfrm>
            <a:off x="5862083" y="1769638"/>
            <a:ext cx="6096000" cy="4801314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ja-JP" dirty="0"/>
              <a:t>Additional file 2: </a:t>
            </a:r>
            <a:r>
              <a:rPr lang="en-US" altLang="ja-JP" b="1" dirty="0"/>
              <a:t>Figure S2. </a:t>
            </a:r>
            <a:r>
              <a:rPr lang="en-US" altLang="ja-JP" dirty="0"/>
              <a:t>Influence of CT on the antitumor efficacy of antitumor drugs in a tumor-bearing mouse model. We investigated the influence of CT administration in a mouse model with subcutaneously transplanted human prostate cancer cells (PC-3) using cisplatin (CDDP). Oxidative stress plays an important role in its anticancer action compared with that of 5-FU. As shown in Figure S2, no difference was noted in the tumor growth rate between the control and CT treatment groups. In addition, a similar degree of antitumor activity was noted in the CDDP anticancer drug treatment group and anticancer drug +CDDP+CT treatment group. These findings confirm that CT does not influence tumor proliferation or the antitumor effects of CDDP, an anticancer drug. PC-3 vs CT280: No significant difference (two-tailed Student’s t-test). PC-3 vs CDDP: * &lt; 0.05 (two-tailed Student’s t-test). CDDP vs CDDP+CT70, CDDP+CT140, and CDDP+CT280: No significant difference. (</a:t>
            </a:r>
            <a:r>
              <a:rPr lang="en-US" altLang="ja-JP" dirty="0" err="1"/>
              <a:t>Dunnet’s</a:t>
            </a:r>
            <a:r>
              <a:rPr lang="en-US" altLang="ja-JP" dirty="0"/>
              <a:t> multiple composition test)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D590DD0E-1289-42CF-98B5-D16257A9280D}"/>
              </a:ext>
            </a:extLst>
          </p:cNvPr>
          <p:cNvSpPr txBox="1"/>
          <p:nvPr/>
        </p:nvSpPr>
        <p:spPr>
          <a:xfrm>
            <a:off x="1328086" y="287048"/>
            <a:ext cx="1013880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Additional file 2 of Oral administration of cystine and theanine attenuates 5-fluorouracil-induced intestinal</a:t>
            </a:r>
          </a:p>
          <a:p>
            <a:r>
              <a:rPr lang="en-US" altLang="ja-JP" dirty="0"/>
              <a:t>mucositis and diarrhea by suppressing both glutathione level decrease and ROS production in the small </a:t>
            </a:r>
          </a:p>
          <a:p>
            <a:r>
              <a:rPr lang="en-US" altLang="ja-JP" dirty="0"/>
              <a:t>intestine of mucositis mouse model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8123985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21</TotalTime>
  <Words>222</Words>
  <Application>Microsoft Office PowerPoint</Application>
  <PresentationFormat>ワイド画面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修正版Figure</dc:title>
  <dc:creator>米田　純也</dc:creator>
  <cp:lastModifiedBy>Junya Yoneda</cp:lastModifiedBy>
  <cp:revision>57</cp:revision>
  <dcterms:created xsi:type="dcterms:W3CDTF">2019-03-28T05:20:39Z</dcterms:created>
  <dcterms:modified xsi:type="dcterms:W3CDTF">2021-06-23T01:37:28Z</dcterms:modified>
</cp:coreProperties>
</file>